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9345613" cy="70453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345600" cy="704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049640" cy="35244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294160" y="-360"/>
            <a:ext cx="4050000" cy="35244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911320" y="528480"/>
            <a:ext cx="3522960" cy="26416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600" rIns="936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34920" y="3346560"/>
            <a:ext cx="7475760" cy="317016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692400"/>
            <a:ext cx="4049640" cy="35100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294160" y="6692400"/>
            <a:ext cx="4050000" cy="351000"/>
          </a:xfrm>
          <a:prstGeom prst="rect">
            <a:avLst/>
          </a:prstGeom>
          <a:noFill/>
          <a:ln w="0">
            <a:noFill/>
          </a:ln>
        </p:spPr>
        <p:txBody>
          <a:bodyPr lIns="93600" rIns="936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BC10A4-3D30-4CAB-BD36-EAC0E8EA466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2911320" y="528480"/>
            <a:ext cx="3522960" cy="264168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934920" y="3346560"/>
            <a:ext cx="7475760" cy="3170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5294160" y="6692760"/>
            <a:ext cx="4050000" cy="351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600" rIns="936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FA4631-F309-480D-9B54-2663AA3D5C1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7147A-8BBF-4771-B16B-B597527DDA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59DDC-0A93-4CC6-8424-BA26865D24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E69F2A-5573-487D-A2A6-0D0F239649E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409BF-AC6A-4E2B-BA1E-096E205B1C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425CA-362C-417B-8E70-4E5753B105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04313D-EBF3-4C34-B10F-A19AE74A70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A1567-9A6C-4151-A94F-8D63D53644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3EEEF-2E68-4806-B596-11F4CD6B4B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4F1EC-F722-4963-8CA7-A595B970CC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EA307A-78EF-4FBB-B637-07E9E4AF64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14CD9-FF47-4771-9CD1-B30D1517C4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D35CE-E5BC-457D-9952-FE00AA65E9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6914E8-E798-42D3-A7BD-354A1CABDB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7" descr="MYMIV Rep.jpg"/>
          <p:cNvPicPr/>
          <p:nvPr/>
        </p:nvPicPr>
        <p:blipFill>
          <a:blip r:embed="rId1">
            <a:lum bright="-10000"/>
          </a:blip>
          <a:srcRect l="1838" t="14725" r="2757" b="21472"/>
          <a:stretch/>
        </p:blipFill>
        <p:spPr>
          <a:xfrm>
            <a:off x="2666880" y="1905120"/>
            <a:ext cx="4114800" cy="205740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7"/>
          <p:cNvSpPr/>
          <p:nvPr/>
        </p:nvSpPr>
        <p:spPr>
          <a:xfrm>
            <a:off x="4938120" y="4038480"/>
            <a:ext cx="1748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YCp-CRAC3 (ToLCKeV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8"/>
          <p:cNvSpPr/>
          <p:nvPr/>
        </p:nvSpPr>
        <p:spPr>
          <a:xfrm>
            <a:off x="3351600" y="4038480"/>
            <a:ext cx="61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YCp5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0"/>
          <p:cNvSpPr/>
          <p:nvPr/>
        </p:nvSpPr>
        <p:spPr>
          <a:xfrm>
            <a:off x="914400" y="4495680"/>
            <a:ext cx="7543800" cy="653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2. Geminiviral replication in yeast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Yeast cells were transformed with wildtype YCp50 plasmid or YCp-CRAC3 (ToLCKeV) and incubated at 30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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 for five days in URA</a:t>
            </a:r>
            <a:r>
              <a:rPr b="0" lang="en-US" sz="12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medium. Yeast transformed with YCp50 grew normally while yeast transformed with YCp-CRAC3 (ToLCKeV) exhibited delayed growth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14:31:33Z</dcterms:created>
  <dc:creator>Kalyan</dc:creator>
  <dc:description/>
  <dc:language>en-US</dc:language>
  <cp:lastModifiedBy>sravanthi</cp:lastModifiedBy>
  <dcterms:modified xsi:type="dcterms:W3CDTF">2011-03-02T12:11:54Z</dcterms:modified>
  <cp:revision>61</cp:revision>
  <dc:subject/>
  <dc:title>Slide 1</dc:title>
</cp:coreProperties>
</file>